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35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4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7E202CE-064F-471B-9988-8503A7D4B4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BB2D26D-41A1-47E5-B67A-2BEC3B77AF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C8A5172-0AD6-4362-8290-547DA9BBA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21A6FB-7A34-419A-91EA-BEBD0D1D6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84773E7-5F2D-4736-B686-CA9B5D44D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770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04F0220-E8DE-49D0-B028-BD16849C62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09840AF-E5B7-4ECA-B7D2-744D1186F5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3710592-6A91-4A7A-A309-D775E0A39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22BB1C8-C26E-4DF5-B08B-581775C655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B9DF1E1-D372-47F1-AC63-3D5A824BD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4812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4BE0D43-B333-4A2C-82A2-668B194CF5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B7A2A43-EE1C-4145-A8C7-BF25658481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CA433C2-7722-400C-8F31-0E2A40AAD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ACB5391-954E-447F-90D6-F5B3C32F4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AB748A7-1627-4E2F-AA80-3F13DE046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8927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2ADCF9-9697-4D9F-A3FD-2A9C5B4091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B91F101-D0A4-4D56-B4DC-EEAA25F3CE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8E75C56-3517-45C5-A74D-B93A408E1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2A781AD-A8DD-47A0-B5EF-7891A7412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803F665-C515-4242-959C-AC17B3A16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7729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5C0538-C6E8-4EE2-A8E7-5E7AE3845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6DCCF82-109E-46A4-9391-9D16FFF9BE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26D1C2E-EC14-4522-9198-11FE033BD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990D604-25E2-4F94-A43C-2B13ED186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B5E016D-9123-4057-9D00-E09B34F1C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5676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E567A90-BDD2-43AA-8B76-A65C333BB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09D7B5D-7A49-4DB4-B42C-CAE78580D3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4192551-CC07-4A4E-96F0-7F51E5B55F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EBB1A63-FDDE-44B0-87B5-6E9241F36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F740D98-14AB-466C-9DD7-71FE6085C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31254BB-D699-4077-96CF-2193CEA49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8285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F4A792-D2BE-4E7D-925F-74857027A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73CF971-CD1B-485C-8BF1-4AF7228A88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79184F0-37F0-42E5-8E18-1003CD3C14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EC9E961-1F9F-4BC9-AA12-182B5D75DC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727B0A0-412F-4B74-9A39-667B6C4276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CDF4F8A-6E1F-4EA9-BA9F-3215D2E90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BF7CFF5-1726-46D6-AB38-21E8733CC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EBB6DEB-FC6F-486E-BC70-06146300D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2338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93B5749-EB8B-4EB9-B675-068343F9F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1BC5709-3351-4893-8844-1AA00F2CD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75FF2A3-FD2B-42F7-8DC9-27E8D9E8A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FECE87E-68BE-4EDB-89BC-271CA0742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7920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300A0A70-4E44-493B-8798-DBA368A90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BC7C82A-7531-4B37-9130-0BC31B60A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FB7A848-29AA-4370-9058-CE4338E0C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3055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C7D534-086E-4E5A-A33C-9260A943D4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C278E9B-41C8-47B1-A50C-0E4351F765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521ABDC-7550-4AB7-B548-A58E0F3848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C6E04C7-3C5E-4103-899B-A0F857AEA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7712B13-FB19-447B-BE9A-06CC36E25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CCAF2B1-B28E-4D95-B1BD-973533CE5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3484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09421F-B961-477D-B9F8-03FDFD924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FF3BCCF-9C35-45B4-85BE-6F9E399465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FB52B56-E582-4D28-8084-6CED62A6FC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510AD0E-635F-4D93-9DC5-AC789A264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36B2C4E-02F3-4C35-AB5B-6CBF2DFF9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69DBA68-AF45-4289-AEC7-7B79EDD3C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0789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F4CC086-D612-42DD-A149-1DF177D658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F0B4191-8E02-49C2-924F-524D30B967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5EB1B58-63B7-4BAB-9ED1-6E5752B5E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9D14A-54D4-4A2D-9455-AF843D285B91}" type="datetimeFigureOut">
              <a:rPr lang="de-DE" smtClean="0"/>
              <a:t>03.05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72329E-5B9E-4454-9657-BA044E771E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890C5F1-B3B9-4C27-9FD2-B5FFE1BB75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5937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75C13125-7B3D-446F-AB5F-3AA2005DAF46}"/>
              </a:ext>
            </a:extLst>
          </p:cNvPr>
          <p:cNvSpPr txBox="1"/>
          <p:nvPr/>
        </p:nvSpPr>
        <p:spPr>
          <a:xfrm>
            <a:off x="544945" y="96330"/>
            <a:ext cx="944634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Supplement Table 2</a:t>
            </a:r>
          </a:p>
          <a:p>
            <a:r>
              <a:rPr lang="de-DE" sz="900" dirty="0"/>
              <a:t>Univariate and multivariable Cox </a:t>
            </a:r>
            <a:r>
              <a:rPr lang="de-DE" sz="900" dirty="0" err="1"/>
              <a:t>regression</a:t>
            </a:r>
            <a:r>
              <a:rPr lang="de-DE" sz="900" dirty="0"/>
              <a:t> </a:t>
            </a:r>
            <a:r>
              <a:rPr lang="de-DE" sz="900" dirty="0" err="1"/>
              <a:t>analysis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prognostic</a:t>
            </a:r>
            <a:r>
              <a:rPr lang="de-DE" sz="900" dirty="0"/>
              <a:t> </a:t>
            </a:r>
            <a:r>
              <a:rPr lang="de-DE" sz="900" dirty="0" err="1"/>
              <a:t>factors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MSS, DMFS and RFS </a:t>
            </a:r>
          </a:p>
          <a:p>
            <a:endParaRPr lang="de-DE" sz="900" dirty="0"/>
          </a:p>
        </p:txBody>
      </p:sp>
      <p:graphicFrame>
        <p:nvGraphicFramePr>
          <p:cNvPr id="4" name="Tabelle 4">
            <a:extLst>
              <a:ext uri="{FF2B5EF4-FFF2-40B4-BE49-F238E27FC236}">
                <a16:creationId xmlns:a16="http://schemas.microsoft.com/office/drawing/2014/main" id="{88F2657F-A419-4E31-A880-ADEAEE4E77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1669713"/>
              </p:ext>
            </p:extLst>
          </p:nvPr>
        </p:nvGraphicFramePr>
        <p:xfrm>
          <a:off x="544944" y="608289"/>
          <a:ext cx="10102433" cy="56096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28675">
                  <a:extLst>
                    <a:ext uri="{9D8B030D-6E8A-4147-A177-3AD203B41FA5}">
                      <a16:colId xmlns:a16="http://schemas.microsoft.com/office/drawing/2014/main" val="1694609349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1315797244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2261007126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1359929737"/>
                    </a:ext>
                  </a:extLst>
                </a:gridCol>
                <a:gridCol w="1297172">
                  <a:extLst>
                    <a:ext uri="{9D8B030D-6E8A-4147-A177-3AD203B41FA5}">
                      <a16:colId xmlns:a16="http://schemas.microsoft.com/office/drawing/2014/main" val="3397778135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1032792223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3598060966"/>
                    </a:ext>
                  </a:extLst>
                </a:gridCol>
                <a:gridCol w="648586">
                  <a:extLst>
                    <a:ext uri="{9D8B030D-6E8A-4147-A177-3AD203B41FA5}">
                      <a16:colId xmlns:a16="http://schemas.microsoft.com/office/drawing/2014/main" val="4151014787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val="4237910807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648947862"/>
                    </a:ext>
                  </a:extLst>
                </a:gridCol>
              </a:tblGrid>
              <a:tr h="229985">
                <a:tc gridSpan="2">
                  <a:txBody>
                    <a:bodyPr/>
                    <a:lstStyle/>
                    <a:p>
                      <a:pPr algn="l"/>
                      <a:endParaRPr lang="de-DE" sz="900" dirty="0"/>
                    </a:p>
                  </a:txBody>
                  <a:tcPr marT="41564" marB="41564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</a:tcPr>
                </a:tc>
                <a:tc gridSpan="2">
                  <a:txBody>
                    <a:bodyPr/>
                    <a:lstStyle/>
                    <a:p>
                      <a:r>
                        <a:rPr lang="de-DE" sz="900" dirty="0"/>
                        <a:t>Univariate</a:t>
                      </a:r>
                      <a:endParaRPr lang="de-DE" sz="900" dirty="0">
                        <a:highlight>
                          <a:srgbClr val="FFFF00"/>
                        </a:highlight>
                      </a:endParaRPr>
                    </a:p>
                  </a:txBody>
                  <a:tcPr marT="41564" marB="41564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Multivariab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Multivariab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Multivariable</a:t>
                      </a:r>
                    </a:p>
                    <a:p>
                      <a:r>
                        <a:rPr lang="de-DE" sz="900" dirty="0"/>
                        <a:t>(all variables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0428230"/>
                  </a:ext>
                </a:extLst>
              </a:tr>
              <a:tr h="379272">
                <a:tc>
                  <a:txBody>
                    <a:bodyPr/>
                    <a:lstStyle/>
                    <a:p>
                      <a:pPr algn="l"/>
                      <a:r>
                        <a:rPr lang="de-DE" sz="900" dirty="0" err="1"/>
                        <a:t>Patients</a:t>
                      </a:r>
                      <a:r>
                        <a:rPr lang="de-DE" sz="900" dirty="0"/>
                        <a:t>/</a:t>
                      </a:r>
                      <a:r>
                        <a:rPr lang="de-DE" sz="900" dirty="0" err="1"/>
                        <a:t>cohort</a:t>
                      </a:r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Variables/</a:t>
                      </a:r>
                    </a:p>
                    <a:p>
                      <a:pPr algn="l"/>
                      <a:r>
                        <a:rPr lang="de-DE" sz="900" dirty="0" err="1"/>
                        <a:t>Prognostic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factors</a:t>
                      </a:r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HR (95% CI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p-</a:t>
                      </a:r>
                      <a:r>
                        <a:rPr lang="de-DE" sz="900" dirty="0" err="1"/>
                        <a:t>value</a:t>
                      </a:r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HR (95% CI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p-</a:t>
                      </a:r>
                      <a:r>
                        <a:rPr lang="de-DE" sz="900" dirty="0" err="1"/>
                        <a:t>value</a:t>
                      </a:r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HR (95% CI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p-</a:t>
                      </a:r>
                      <a:r>
                        <a:rPr lang="de-DE" sz="900" dirty="0" err="1"/>
                        <a:t>value</a:t>
                      </a:r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HR (95%CI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p-</a:t>
                      </a:r>
                      <a:r>
                        <a:rPr lang="de-DE" sz="900" dirty="0" err="1"/>
                        <a:t>value</a:t>
                      </a:r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762123"/>
                  </a:ext>
                </a:extLst>
              </a:tr>
              <a:tr h="193625">
                <a:tc rowSpan="7">
                  <a:txBody>
                    <a:bodyPr/>
                    <a:lstStyle/>
                    <a:p>
                      <a:r>
                        <a:rPr lang="de-DE" sz="900" b="1" dirty="0" err="1"/>
                        <a:t>Entire</a:t>
                      </a:r>
                      <a:r>
                        <a:rPr lang="de-DE" sz="900" b="1" dirty="0"/>
                        <a:t> </a:t>
                      </a:r>
                      <a:r>
                        <a:rPr lang="de-DE" sz="900" b="1" dirty="0" err="1"/>
                        <a:t>cohort</a:t>
                      </a:r>
                      <a:endParaRPr lang="de-DE" sz="900" b="1" dirty="0"/>
                    </a:p>
                    <a:p>
                      <a:r>
                        <a:rPr lang="de-DE" sz="900" dirty="0"/>
                        <a:t>(n=88)</a:t>
                      </a:r>
                    </a:p>
                    <a:p>
                      <a:endParaRPr lang="de-DE" sz="900" dirty="0"/>
                    </a:p>
                    <a:p>
                      <a:r>
                        <a:rPr lang="de-DE" sz="900" dirty="0"/>
                        <a:t>(Events:</a:t>
                      </a:r>
                    </a:p>
                    <a:p>
                      <a:r>
                        <a:rPr lang="de-DE" sz="900" dirty="0"/>
                        <a:t>MSS: 16</a:t>
                      </a:r>
                    </a:p>
                    <a:p>
                      <a:r>
                        <a:rPr lang="de-DE" sz="900" dirty="0"/>
                        <a:t>DMFS: 25</a:t>
                      </a:r>
                    </a:p>
                    <a:p>
                      <a:r>
                        <a:rPr lang="de-DE" sz="900" dirty="0"/>
                        <a:t>RFS: 32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MSS</a:t>
                      </a:r>
                    </a:p>
                  </a:txBody>
                  <a:tcPr marT="41564" marB="41564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5231449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r>
                        <a:rPr lang="de-DE" sz="900" b="1" dirty="0" err="1"/>
                        <a:t>Entire</a:t>
                      </a:r>
                      <a:r>
                        <a:rPr lang="de-DE" sz="900" b="1" dirty="0"/>
                        <a:t> </a:t>
                      </a:r>
                      <a:r>
                        <a:rPr lang="de-DE" sz="900" b="1" dirty="0" err="1"/>
                        <a:t>cohort</a:t>
                      </a:r>
                      <a:endParaRPr lang="de-DE" sz="900" b="1" dirty="0"/>
                    </a:p>
                    <a:p>
                      <a:r>
                        <a:rPr lang="de-DE" sz="900" dirty="0"/>
                        <a:t>(n=88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7-marker </a:t>
                      </a:r>
                      <a:r>
                        <a:rPr lang="de-DE" sz="900" dirty="0" err="1"/>
                        <a:t>signature</a:t>
                      </a:r>
                      <a:r>
                        <a:rPr lang="de-DE" sz="900" dirty="0"/>
                        <a:t>*</a:t>
                      </a:r>
                    </a:p>
                  </a:txBody>
                  <a:tcPr marT="41564" marB="41564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049 (1.212-3.463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7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727 (0.977-3.051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060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740 (0.993-3.051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053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714 (0.966-3.041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065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802676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umor </a:t>
                      </a:r>
                      <a:r>
                        <a:rPr lang="de-DE" sz="9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hickness</a:t>
                      </a:r>
                      <a:r>
                        <a:rPr lang="de-DE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mm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.267 (1.099-1.460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01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208 (1.045-1.398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10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211 (1.050-1.397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8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213 (1.046-1.406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10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9306042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r>
                        <a:rPr lang="de-DE" sz="900" dirty="0"/>
                        <a:t>(Events:</a:t>
                      </a:r>
                    </a:p>
                    <a:p>
                      <a:r>
                        <a:rPr lang="de-DE" sz="900" dirty="0"/>
                        <a:t>RFS: XX</a:t>
                      </a:r>
                    </a:p>
                    <a:p>
                      <a:r>
                        <a:rPr lang="de-DE" sz="900" dirty="0"/>
                        <a:t>DMFS: YY</a:t>
                      </a:r>
                    </a:p>
                    <a:p>
                      <a:r>
                        <a:rPr lang="de-DE" sz="900" dirty="0"/>
                        <a:t>MSS: ZZ)</a:t>
                      </a:r>
                    </a:p>
                  </a:txBody>
                  <a:tcPr marT="41564" marB="41564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 err="1"/>
                        <a:t>Ulceration</a:t>
                      </a:r>
                      <a:r>
                        <a:rPr lang="de-DE" sz="900" dirty="0"/>
                        <a:t> (1=Yes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121 (0.770-5.842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1458</a:t>
                      </a:r>
                      <a:endParaRPr lang="de-DE" sz="900" b="1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092 (0.366-3.256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874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125 (0.380-3.333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831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4099109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 err="1"/>
                        <a:t>Nodal</a:t>
                      </a:r>
                      <a:r>
                        <a:rPr lang="de-DE" sz="900" dirty="0"/>
                        <a:t> </a:t>
                      </a:r>
                      <a:r>
                        <a:rPr lang="de-DE" sz="900" dirty="0" err="1"/>
                        <a:t>status</a:t>
                      </a:r>
                      <a:r>
                        <a:rPr lang="de-DE" sz="900" dirty="0"/>
                        <a:t> (1=Pos)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4.509 (1.684-12.072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2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2.659 (0.910-7.769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073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2.702 (0.941-7.759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064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2.803 (0.955-8.224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060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851271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Age (</a:t>
                      </a:r>
                      <a:r>
                        <a:rPr lang="de-DE" sz="900" dirty="0" err="1"/>
                        <a:t>years</a:t>
                      </a:r>
                      <a:r>
                        <a:rPr lang="de-DE" sz="900" dirty="0"/>
                        <a:t>)</a:t>
                      </a:r>
                      <a:endParaRPr lang="de-DE" sz="9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002 (0.973-1.033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879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1.007 (0.975-1.040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670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729473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Gender (</a:t>
                      </a:r>
                      <a:r>
                        <a:rPr lang="de-DE" sz="900" dirty="0" err="1"/>
                        <a:t>female</a:t>
                      </a:r>
                      <a:r>
                        <a:rPr lang="de-DE" sz="900" dirty="0"/>
                        <a:t>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008 (0.375-2.707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987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1.191 (0.431-3.288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736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3381594"/>
                  </a:ext>
                </a:extLst>
              </a:tr>
              <a:tr h="0">
                <a:tc rowSpan="7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MFS</a:t>
                      </a:r>
                    </a:p>
                  </a:txBody>
                  <a:tcPr marT="41564" marB="4156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237590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-marker 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ignature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T="41564" marB="4156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145 (1.430-3.218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808 (1.159-2.819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9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841 (1.185-2.861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67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797 (1.152-2.802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9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22406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dirty="0"/>
                    </a:p>
                  </a:txBody>
                  <a:tcPr marT="41564" marB="4156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umor 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hickness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mm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.280 (1.139-1.438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215 (1.078-1.370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225 (1.090-1.376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6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219 (1.079-1.377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9359452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Ulceration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1=Yes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420 (1.069-5.483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34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280 (0.524-3.130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588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265 (0.516-3.098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607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014342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odal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tatus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1=Pos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4.233 (1.916-9.356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214 (0.902-5.434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082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329 (0.966-5.617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/>
                        <a:t>0.0598</a:t>
                      </a:r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269 (0.894-5.755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084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38584914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ge (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years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998 (0.975-1.022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870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1.005 (0.977-1.034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736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294341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der (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female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825 (0.371-1.837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638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968 (0.423-2.214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900" b="0" dirty="0"/>
                        <a:t>0.937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89889896"/>
                  </a:ext>
                </a:extLst>
              </a:tr>
              <a:tr h="0">
                <a:tc rowSpan="7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RFS</a:t>
                      </a:r>
                    </a:p>
                  </a:txBody>
                  <a:tcPr marT="41564" marB="4156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9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1031577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dirty="0"/>
                    </a:p>
                  </a:txBody>
                  <a:tcPr marT="41564" marB="4156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-marker 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ignature</a:t>
                      </a:r>
                      <a:endParaRPr lang="de-DE" sz="9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T="41564" marB="41564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38.680 (5.265-284.153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30.604 (4.112-227.757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30.751 (4.135-228.680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8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30.549 (4.103-227.440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5184015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dirty="0"/>
                    </a:p>
                  </a:txBody>
                  <a:tcPr marT="41564" marB="41564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umor 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hickness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mm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.250 (1.132-1.381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&lt;</a:t>
                      </a:r>
                      <a:r>
                        <a:rPr lang="de-DE" sz="9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00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137 (1.019-1.268)</a:t>
                      </a:r>
                      <a:endParaRPr lang="de-DE" sz="9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21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142 (1.029-1.265)</a:t>
                      </a:r>
                      <a:endParaRPr lang="de-DE" sz="9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124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140 (1.021-1.275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20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4518662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Ulceration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1=Yes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027 (0.997-4.122)</a:t>
                      </a:r>
                      <a:endParaRPr lang="de-DE" sz="9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0510</a:t>
                      </a:r>
                      <a:endParaRPr lang="de-DE" sz="900" b="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111 (0.509-2.424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792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144 (0.515-2.541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740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94741958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odal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tatus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(1=Pos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3.786 (1.860-7.706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00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150 (1.014-4.560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45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2.175 (1.031-4.590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1" dirty="0"/>
                        <a:t>0.0415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2.153 (0.985-4.704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054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84876354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endParaRPr lang="de-DE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ge (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years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1.004 (0.982-1.026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736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1.012 (0.987-1.038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340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7309630"/>
                  </a:ext>
                </a:extLst>
              </a:tr>
              <a:tr h="235712">
                <a:tc vMerge="1">
                  <a:txBody>
                    <a:bodyPr/>
                    <a:lstStyle/>
                    <a:p>
                      <a:pPr marL="0" algn="l" defTabSz="914400" rtl="0" eaLnBrk="1" latinLnBrk="0" hangingPunct="1"/>
                      <a:endParaRPr lang="de-DE" sz="9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der (</a:t>
                      </a:r>
                      <a:r>
                        <a:rPr lang="de-DE" sz="90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female</a:t>
                      </a:r>
                      <a:r>
                        <a:rPr lang="de-DE" sz="90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598 (0.288-1.240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0.167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---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690 (0.323-1.472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b="0" dirty="0"/>
                        <a:t>0.337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44883801"/>
                  </a:ext>
                </a:extLst>
              </a:tr>
            </a:tbl>
          </a:graphicData>
        </a:graphic>
      </p:graphicFrame>
      <p:sp>
        <p:nvSpPr>
          <p:cNvPr id="2" name="Textfeld 1">
            <a:extLst>
              <a:ext uri="{FF2B5EF4-FFF2-40B4-BE49-F238E27FC236}">
                <a16:creationId xmlns:a16="http://schemas.microsoft.com/office/drawing/2014/main" id="{64C9680F-0AD5-4FE4-8CC5-35DDDA2C5D05}"/>
              </a:ext>
            </a:extLst>
          </p:cNvPr>
          <p:cNvSpPr txBox="1"/>
          <p:nvPr/>
        </p:nvSpPr>
        <p:spPr>
          <a:xfrm>
            <a:off x="523683" y="6230395"/>
            <a:ext cx="1012369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Endpoints </a:t>
            </a:r>
            <a:r>
              <a:rPr lang="de-DE" sz="900" dirty="0" err="1"/>
              <a:t>melanoma-specific</a:t>
            </a:r>
            <a:r>
              <a:rPr lang="de-DE" sz="900" dirty="0"/>
              <a:t> </a:t>
            </a:r>
            <a:r>
              <a:rPr lang="de-DE" sz="900" dirty="0" err="1"/>
              <a:t>survival</a:t>
            </a:r>
            <a:r>
              <a:rPr lang="de-DE" sz="900" dirty="0"/>
              <a:t> (MSS), </a:t>
            </a:r>
            <a:r>
              <a:rPr lang="de-DE" sz="900" dirty="0" err="1"/>
              <a:t>distant-metastasis</a:t>
            </a:r>
            <a:r>
              <a:rPr lang="de-DE" sz="900" dirty="0"/>
              <a:t> </a:t>
            </a:r>
            <a:r>
              <a:rPr lang="de-DE" sz="900" dirty="0" err="1"/>
              <a:t>survival</a:t>
            </a:r>
            <a:r>
              <a:rPr lang="de-DE" sz="900" dirty="0"/>
              <a:t> (DMFS), </a:t>
            </a:r>
            <a:r>
              <a:rPr lang="de-DE" sz="900" dirty="0" err="1"/>
              <a:t>relapse-free</a:t>
            </a:r>
            <a:r>
              <a:rPr lang="de-DE" sz="900" dirty="0"/>
              <a:t> </a:t>
            </a:r>
            <a:r>
              <a:rPr lang="de-DE" sz="900" dirty="0" err="1"/>
              <a:t>survival</a:t>
            </a:r>
            <a:r>
              <a:rPr lang="de-DE" sz="900" dirty="0"/>
              <a:t> (RFS); * Due </a:t>
            </a:r>
            <a:r>
              <a:rPr lang="de-DE" sz="900" dirty="0" err="1"/>
              <a:t>to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absence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MSS and DMFS </a:t>
            </a:r>
            <a:r>
              <a:rPr lang="de-DE" sz="900" dirty="0" err="1"/>
              <a:t>events</a:t>
            </a:r>
            <a:r>
              <a:rPr lang="de-DE" sz="900" dirty="0"/>
              <a:t> in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low-risk</a:t>
            </a:r>
            <a:r>
              <a:rPr lang="de-DE" sz="900" dirty="0"/>
              <a:t> </a:t>
            </a:r>
            <a:r>
              <a:rPr lang="de-DE" sz="900" dirty="0" err="1"/>
              <a:t>group</a:t>
            </a:r>
            <a:r>
              <a:rPr lang="de-DE" sz="900" dirty="0"/>
              <a:t>,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numerical</a:t>
            </a:r>
            <a:r>
              <a:rPr lang="de-DE" sz="900" dirty="0"/>
              <a:t> </a:t>
            </a:r>
            <a:r>
              <a:rPr lang="de-DE" sz="900" dirty="0" err="1"/>
              <a:t>risk</a:t>
            </a:r>
            <a:r>
              <a:rPr lang="de-DE" sz="900" dirty="0"/>
              <a:t> score variable (</a:t>
            </a:r>
            <a:r>
              <a:rPr lang="de-DE" sz="900" dirty="0" err="1"/>
              <a:t>continuous</a:t>
            </a:r>
            <a:r>
              <a:rPr lang="de-DE" sz="900" dirty="0"/>
              <a:t> variable) was </a:t>
            </a:r>
            <a:r>
              <a:rPr lang="de-DE" sz="900" dirty="0" err="1"/>
              <a:t>used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analyses</a:t>
            </a:r>
            <a:r>
              <a:rPr lang="de-DE" sz="900" dirty="0"/>
              <a:t> (</a:t>
            </a:r>
            <a:r>
              <a:rPr lang="de-DE" sz="900" dirty="0" err="1"/>
              <a:t>instead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dichotomous</a:t>
            </a:r>
            <a:r>
              <a:rPr lang="de-DE" sz="900" dirty="0"/>
              <a:t> </a:t>
            </a:r>
            <a:r>
              <a:rPr lang="de-DE" sz="900" dirty="0" err="1"/>
              <a:t>risk</a:t>
            </a:r>
            <a:r>
              <a:rPr lang="de-DE" sz="900" dirty="0"/>
              <a:t> score variable). </a:t>
            </a:r>
            <a:r>
              <a:rPr lang="de-DE" sz="900" dirty="0" err="1"/>
              <a:t>Since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small</a:t>
            </a:r>
            <a:r>
              <a:rPr lang="de-DE" sz="900" dirty="0"/>
              <a:t> </a:t>
            </a:r>
            <a:r>
              <a:rPr lang="de-DE" sz="900" dirty="0" err="1"/>
              <a:t>scale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the</a:t>
            </a:r>
            <a:r>
              <a:rPr lang="de-DE" sz="900" dirty="0"/>
              <a:t> </a:t>
            </a:r>
            <a:r>
              <a:rPr lang="de-DE" sz="900" dirty="0" err="1"/>
              <a:t>metric</a:t>
            </a:r>
            <a:r>
              <a:rPr lang="de-DE" sz="900" dirty="0"/>
              <a:t> </a:t>
            </a:r>
            <a:r>
              <a:rPr lang="de-DE" sz="900" dirty="0" err="1"/>
              <a:t>risk</a:t>
            </a:r>
            <a:r>
              <a:rPr lang="de-DE" sz="900" dirty="0"/>
              <a:t> score </a:t>
            </a:r>
            <a:r>
              <a:rPr lang="de-DE" sz="900" dirty="0" err="1"/>
              <a:t>leads</a:t>
            </a:r>
            <a:r>
              <a:rPr lang="de-DE" sz="900" dirty="0"/>
              <a:t> </a:t>
            </a:r>
            <a:r>
              <a:rPr lang="de-DE" sz="900" dirty="0" err="1"/>
              <a:t>to</a:t>
            </a:r>
            <a:r>
              <a:rPr lang="de-DE" sz="900" dirty="0"/>
              <a:t> </a:t>
            </a:r>
            <a:r>
              <a:rPr lang="de-DE" sz="900" dirty="0" err="1"/>
              <a:t>very</a:t>
            </a:r>
            <a:r>
              <a:rPr lang="de-DE" sz="900" dirty="0"/>
              <a:t> high HR </a:t>
            </a:r>
            <a:r>
              <a:rPr lang="de-DE" sz="900" dirty="0" err="1"/>
              <a:t>values</a:t>
            </a:r>
            <a:r>
              <a:rPr lang="de-DE" sz="900" dirty="0"/>
              <a:t>, </a:t>
            </a:r>
            <a:r>
              <a:rPr lang="de-DE" sz="900" dirty="0" err="1"/>
              <a:t>the</a:t>
            </a:r>
            <a:r>
              <a:rPr lang="de-DE" sz="900" dirty="0"/>
              <a:t> score was </a:t>
            </a:r>
            <a:r>
              <a:rPr lang="de-DE" sz="900" dirty="0" err="1"/>
              <a:t>transformed</a:t>
            </a:r>
            <a:r>
              <a:rPr lang="de-DE" sz="900" dirty="0"/>
              <a:t> </a:t>
            </a:r>
            <a:r>
              <a:rPr lang="de-DE" sz="900" dirty="0" err="1"/>
              <a:t>linearly</a:t>
            </a:r>
            <a:r>
              <a:rPr lang="de-DE" sz="900" dirty="0"/>
              <a:t> (</a:t>
            </a:r>
            <a:r>
              <a:rPr lang="de-DE" sz="900" dirty="0" err="1"/>
              <a:t>multiplied</a:t>
            </a:r>
            <a:r>
              <a:rPr lang="de-DE" sz="900" dirty="0"/>
              <a:t> </a:t>
            </a:r>
            <a:r>
              <a:rPr lang="de-DE" sz="900" dirty="0" err="1"/>
              <a:t>by</a:t>
            </a:r>
            <a:r>
              <a:rPr lang="de-DE" sz="900" dirty="0"/>
              <a:t> 10). The </a:t>
            </a:r>
            <a:r>
              <a:rPr lang="de-DE" sz="900" dirty="0" err="1"/>
              <a:t>interpretation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HR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risk</a:t>
            </a:r>
            <a:r>
              <a:rPr lang="de-DE" sz="900" dirty="0"/>
              <a:t> score </a:t>
            </a:r>
            <a:r>
              <a:rPr lang="de-DE" sz="900" dirty="0" err="1"/>
              <a:t>now</a:t>
            </a:r>
            <a:r>
              <a:rPr lang="de-DE" sz="900" dirty="0"/>
              <a:t> </a:t>
            </a:r>
            <a:r>
              <a:rPr lang="de-DE" sz="900" dirty="0" err="1"/>
              <a:t>does</a:t>
            </a:r>
            <a:r>
              <a:rPr lang="de-DE" sz="900" dirty="0"/>
              <a:t> not </a:t>
            </a:r>
            <a:r>
              <a:rPr lang="de-DE" sz="900" dirty="0" err="1"/>
              <a:t>refer</a:t>
            </a:r>
            <a:r>
              <a:rPr lang="de-DE" sz="900" dirty="0"/>
              <a:t> </a:t>
            </a:r>
            <a:r>
              <a:rPr lang="de-DE" sz="900" dirty="0" err="1"/>
              <a:t>to</a:t>
            </a:r>
            <a:r>
              <a:rPr lang="de-DE" sz="900" dirty="0"/>
              <a:t> </a:t>
            </a:r>
            <a:r>
              <a:rPr lang="de-DE" sz="900" dirty="0" err="1"/>
              <a:t>increase</a:t>
            </a:r>
            <a:r>
              <a:rPr lang="de-DE" sz="900" dirty="0"/>
              <a:t> in </a:t>
            </a:r>
            <a:r>
              <a:rPr lang="de-DE" sz="900" dirty="0" err="1"/>
              <a:t>the</a:t>
            </a:r>
            <a:r>
              <a:rPr lang="de-DE" sz="900" dirty="0"/>
              <a:t> score </a:t>
            </a:r>
            <a:r>
              <a:rPr lang="de-DE" sz="900" dirty="0" err="1"/>
              <a:t>by</a:t>
            </a:r>
            <a:r>
              <a:rPr lang="de-DE" sz="900" dirty="0"/>
              <a:t> 1, but </a:t>
            </a:r>
            <a:r>
              <a:rPr lang="de-DE" sz="900" dirty="0" err="1"/>
              <a:t>by</a:t>
            </a:r>
            <a:r>
              <a:rPr lang="de-DE" sz="900" dirty="0"/>
              <a:t> 0.1.</a:t>
            </a:r>
          </a:p>
        </p:txBody>
      </p:sp>
    </p:spTree>
    <p:extLst>
      <p:ext uri="{BB962C8B-B14F-4D97-AF65-F5344CB8AC3E}">
        <p14:creationId xmlns:p14="http://schemas.microsoft.com/office/powerpoint/2010/main" val="4136064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9</Words>
  <Application>Microsoft Macintosh PowerPoint</Application>
  <PresentationFormat>Widescreen</PresentationFormat>
  <Paragraphs>19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Werner</dc:creator>
  <cp:lastModifiedBy>Reschke, Robin</cp:lastModifiedBy>
  <cp:revision>283</cp:revision>
  <cp:lastPrinted>2021-04-06T12:26:40Z</cp:lastPrinted>
  <dcterms:created xsi:type="dcterms:W3CDTF">2020-07-16T14:24:27Z</dcterms:created>
  <dcterms:modified xsi:type="dcterms:W3CDTF">2021-05-03T22:23:12Z</dcterms:modified>
</cp:coreProperties>
</file>